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1680" cy="400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755640" y="5078160"/>
            <a:ext cx="6045120" cy="48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278160" cy="53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4"/>
          </p:nvPr>
        </p:nvSpPr>
        <p:spPr>
          <a:xfrm>
            <a:off x="4278240" y="-360"/>
            <a:ext cx="3278160" cy="53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427824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pt-B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0A09D522-3CA7-43BB-835F-B3B9BCFC9537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Rectangle 7"/>
          <p:cNvSpPr/>
          <p:nvPr/>
        </p:nvSpPr>
        <p:spPr>
          <a:xfrm>
            <a:off x="427824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E7F2180E-E2E6-4C14-9190-42CC3836C38F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6F014-ED97-4CF6-9467-FC40F2A94F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3280" y="43725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83B4C9-9148-4B63-825B-C40414E796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4980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A190A-D6EE-4CBD-8206-8A8D3CF5A9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16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328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16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AD3FF-DB4A-4AB0-87F8-5D503B89CC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45706-EC0E-4137-8A15-1F87DF069B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CE1E7-8B6E-4A0E-9C03-A39B87130A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85660-BCE6-425E-8A20-C20542B7F2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0A88C9-838C-4415-8C08-5685EEBD6C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3280" y="301320"/>
            <a:ext cx="9067680" cy="583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CE2A0-4902-46B9-9FDC-206963AD23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AEAD0-68E7-4873-B409-0DA185E77F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4980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EEAC9-773E-4BBE-83CD-5A2BDA2738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E9E15-5BA5-44B2-9D17-692532991D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46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24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720" y="6886440"/>
            <a:ext cx="234504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pt-BR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816D585E-9898-451E-B0EF-E958D9F33696}" type="slidenum">
              <a:rPr b="0" lang="pt-BR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1"/>
          <p:cNvGrpSpPr/>
          <p:nvPr/>
        </p:nvGrpSpPr>
        <p:grpSpPr>
          <a:xfrm>
            <a:off x="2808360" y="216000"/>
            <a:ext cx="4138560" cy="7018200"/>
            <a:chOff x="2808360" y="216000"/>
            <a:chExt cx="4138560" cy="7018200"/>
          </a:xfrm>
        </p:grpSpPr>
        <p:sp>
          <p:nvSpPr>
            <p:cNvPr id="50" name="Text Box 2"/>
            <p:cNvSpPr/>
            <p:nvPr/>
          </p:nvSpPr>
          <p:spPr>
            <a:xfrm>
              <a:off x="4537080" y="719280"/>
              <a:ext cx="536400" cy="35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08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pt-BR" sz="1800" spc="-1" strike="noStrike">
                  <a:solidFill>
                    <a:srgbClr val="000000"/>
                  </a:solidFill>
                  <a:latin typeface="Arial"/>
                </a:rPr>
                <a:t>ma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" name="Text Box 3"/>
            <p:cNvSpPr/>
            <p:nvPr/>
          </p:nvSpPr>
          <p:spPr>
            <a:xfrm>
              <a:off x="4572000" y="2806560"/>
              <a:ext cx="536400" cy="351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08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pt-BR" sz="18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" name="Text Box 4"/>
            <p:cNvSpPr/>
            <p:nvPr/>
          </p:nvSpPr>
          <p:spPr>
            <a:xfrm>
              <a:off x="4967280" y="1584360"/>
              <a:ext cx="1943280" cy="64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Alcam </a:t>
              </a: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Cd24a </a:t>
              </a: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Itga6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Kit Mitf </a:t>
              </a: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Nt5e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Sox10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" name="Line 5"/>
            <p:cNvSpPr/>
            <p:nvPr/>
          </p:nvSpPr>
          <p:spPr>
            <a:xfrm>
              <a:off x="4824360" y="1152360"/>
              <a:ext cx="0" cy="161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" name="Line 6"/>
            <p:cNvSpPr/>
            <p:nvPr/>
          </p:nvSpPr>
          <p:spPr>
            <a:xfrm>
              <a:off x="4824360" y="3203640"/>
              <a:ext cx="0" cy="1616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" name="Text Box 7"/>
            <p:cNvSpPr/>
            <p:nvPr/>
          </p:nvSpPr>
          <p:spPr>
            <a:xfrm>
              <a:off x="4402080" y="4846680"/>
              <a:ext cx="885960" cy="35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08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pt-BR" sz="1800" spc="-1" strike="noStrike">
                  <a:solidFill>
                    <a:srgbClr val="000000"/>
                  </a:solidFill>
                  <a:latin typeface="Arial"/>
                </a:rPr>
                <a:t>4C11-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" name="Text Box 8"/>
            <p:cNvSpPr/>
            <p:nvPr/>
          </p:nvSpPr>
          <p:spPr>
            <a:xfrm>
              <a:off x="5595840" y="3506760"/>
              <a:ext cx="701640" cy="28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Wnt5a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" name="Line 9"/>
            <p:cNvSpPr/>
            <p:nvPr/>
          </p:nvSpPr>
          <p:spPr>
            <a:xfrm>
              <a:off x="4824360" y="5219640"/>
              <a:ext cx="0" cy="1616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" name="Text Box 10"/>
            <p:cNvSpPr/>
            <p:nvPr/>
          </p:nvSpPr>
          <p:spPr>
            <a:xfrm>
              <a:off x="4390920" y="6862680"/>
              <a:ext cx="897120" cy="351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08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pt-BR" sz="1800" spc="-1" strike="noStrike">
                  <a:solidFill>
                    <a:srgbClr val="000000"/>
                  </a:solidFill>
                  <a:latin typeface="Arial"/>
                </a:rPr>
                <a:t>4C11+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" name="Text Box 11"/>
            <p:cNvSpPr/>
            <p:nvPr/>
          </p:nvSpPr>
          <p:spPr>
            <a:xfrm>
              <a:off x="5003640" y="5448240"/>
              <a:ext cx="1798920" cy="110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Bmi1 </a:t>
              </a: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Cd24a Cd9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Flt1 </a:t>
              </a: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Itga6 </a:t>
              </a: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Jarid1b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Kit </a:t>
              </a: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Klf4 </a:t>
              </a: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Mitf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Nanog </a:t>
              </a: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Ngfr </a:t>
              </a: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Nt5e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i="1" lang="pt-BR" sz="1400" spc="-1" strike="noStrike">
                  <a:solidFill>
                    <a:srgbClr val="dc2300"/>
                  </a:solidFill>
                  <a:latin typeface="Arial"/>
                </a:rPr>
                <a:t>Sox10 </a:t>
              </a:r>
              <a:r>
                <a:rPr b="0" i="1" lang="pt-BR" sz="1400" spc="-1" strike="noStrike">
                  <a:solidFill>
                    <a:srgbClr val="008000"/>
                  </a:solidFill>
                  <a:latin typeface="Arial"/>
                </a:rPr>
                <a:t>Tert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" name="Text Box 12"/>
            <p:cNvSpPr/>
            <p:nvPr/>
          </p:nvSpPr>
          <p:spPr>
            <a:xfrm>
              <a:off x="3132000" y="250920"/>
              <a:ext cx="3416400" cy="35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0840" bIns="45000" anchor="t">
              <a:noAutofit/>
            </a:bodyPr>
            <a:p>
              <a:pPr algn="ctr">
                <a:lnSpc>
                  <a:spcPct val="93000"/>
                </a:lnSpc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i="1" lang="pt-BR" sz="1800" spc="-1" strike="noStrike">
                  <a:solidFill>
                    <a:srgbClr val="000000"/>
                  </a:solidFill>
                  <a:latin typeface="Arial"/>
                </a:rPr>
                <a:t>Melanoma Stem Cell Markers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" name="AutoShape 13"/>
            <p:cNvSpPr/>
            <p:nvPr/>
          </p:nvSpPr>
          <p:spPr>
            <a:xfrm>
              <a:off x="2808360" y="216000"/>
              <a:ext cx="4138560" cy="7018200"/>
            </a:xfrm>
            <a:custGeom>
              <a:avLst/>
              <a:gdLst>
                <a:gd name="textAreaLeft" fmla="*/ 360 w 4138560"/>
                <a:gd name="textAreaRight" fmla="*/ 4138200 w 4138560"/>
                <a:gd name="textAreaTop" fmla="*/ 360 h 7018200"/>
                <a:gd name="textAreaBottom" fmla="*/ 7017840 h 7018200"/>
              </a:gdLst>
              <a:ahLst/>
              <a:rect l="textAreaLeft" t="textAreaTop" r="textAreaRight" b="textAreaBottom"/>
              <a:pathLst>
                <a:path w="21600" h="36628">
                  <a:moveTo>
                    <a:pt x="8" y="0"/>
                  </a:moveTo>
                  <a:arcTo wR="8" hR="8" stAng="16200000" swAng="-5400000"/>
                  <a:lnTo>
                    <a:pt x="0" y="36620"/>
                  </a:lnTo>
                  <a:arcTo wR="8" hR="8" stAng="10800000" swAng="-5400000"/>
                  <a:lnTo>
                    <a:pt x="21592" y="36628"/>
                  </a:lnTo>
                  <a:arcTo wR="8" hR="8" stAng="5400000" swAng="-5400000"/>
                  <a:lnTo>
                    <a:pt x="21600" y="8"/>
                  </a:lnTo>
                  <a:arcTo wR="8" hR="8" stAng="0" swAng="-5400000"/>
                  <a:close/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31T02:32:44Z</dcterms:created>
  <dc:creator>Camila Souza</dc:creator>
  <dc:description/>
  <dc:language>en-US</dc:language>
  <cp:lastModifiedBy>Miriam</cp:lastModifiedBy>
  <dcterms:modified xsi:type="dcterms:W3CDTF">2012-08-15T13:03:03Z</dcterms:modified>
  <cp:revision>1</cp:revision>
  <dc:subject/>
  <dc:title>Apresentação do PowerPoint</dc:title>
</cp:coreProperties>
</file>